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7ADE31-F49D-C85B-35B1-BC3908F8EC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FA03D4-48A9-C40C-ADDD-412911296A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C7F0B6-AECD-C037-0792-1D3459176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62C912-604A-70A4-D1FF-E22E66FE0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AF1853-FCD8-D84F-B285-F73753681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863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5432C-1963-6518-B684-F67D8B6205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D72276-3F06-B6E3-321C-194960EFE9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C02B6A-E82A-4D89-B0F8-2D5EA1AD8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7ED2D-7E43-E8D7-6769-3C9F2D8F0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01BBDA-7C42-F4D0-8246-627854E7A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449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0B5849-D965-33F3-1A90-1B3B94763C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3079DD-FE3F-E6F6-EC2D-C8E8BE81ED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C52988-0688-74FA-4E0B-F1AFBD681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7DFDB7-4C77-8879-7A0A-3C395F534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9391D7-CAE8-22B0-2CC9-D0D26D788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171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A579D-F618-DB10-5422-EF900B6DCE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373D73-6691-44A5-42DF-1598259A43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3DBC48-9DB1-1990-E342-56B0A3749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B184D3-5925-5D62-6C9F-94897FA52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D968D8-1302-5064-31B6-D21D11A59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537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1D7DE0-B77E-A03B-DB93-EDADFCD72F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652310-A985-3192-81E5-3920A248EC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DB6D75-F19F-97C6-9637-204A7A255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5297D5-9C6F-9DB2-7ABC-11E8210486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777649-78C2-9D57-7582-DA2918882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783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42ABFE-52E6-19A5-55A0-0F3BC4FE45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4FD9AF-AD94-C6C8-61CE-0540250C61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D8F942-AB11-FDE2-1166-83A523A3BD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CBF56E-175A-AE07-4961-0E7CEB428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AA920E-63A1-192F-2774-464BC0876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A49563-895E-EA67-9640-1723BFE24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66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5520A6-8D45-7549-B495-6D773EDBB0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7A5652-C3CF-46FF-35FA-C4A6C782F0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400FDC-D315-78F3-3067-3D9F8916C4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8BF75C-49B2-8724-6B1A-67DC6C6A7E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34F8E5-8DDC-978C-5181-7599EE9B49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9E2FB1-336E-ECED-C8A3-A52CD7D15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CF0ADA-4B9A-FA48-F8E9-C650B8237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0B8DEA-69EA-71C8-EC87-48D454799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671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B1C74D-4409-1C62-2650-8F5875376A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AA9E0D-3063-4809-6D45-3AB82C04A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3B6566-D104-816A-FC01-C2ACAD65F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58B86C-B4BC-5653-86C0-6715CF9BA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278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609B2E-2530-646F-6EA6-F64F03E3CC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074C31-18E9-8BDD-8501-74FDC2F9C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FCB5D6-2E61-6D44-25C1-5A2056E5E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894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89A98A-C0A8-CAF4-627A-57E1D0B868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16EFC3-E27B-6EC4-CFA5-B854F451BA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269C70-6BA8-33AB-44E3-1C8D7CCC29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AF1A53-1947-544E-26BC-393B19554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F78F61-F7A4-FF1C-2D0E-457FF3D46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CC4A74-3B5F-B199-AB1C-2642FE79A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034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AB678-1997-D48E-8F63-957D90FD55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2390FF7-E4CC-A972-D03F-591B6C109A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E93CE2-8B30-5713-7DEF-DECCE372CF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716E04-0750-6AE1-3257-6C8076300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1C1DA8-153F-2E13-7AC7-5204FF3827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9C0558-E90A-CF25-78F7-4BA590C42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861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A9C2FC-FA6E-2782-F707-1C2BEFF7C7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D6C946-736F-60B8-B366-D1FDCB166E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512A6-D747-0764-CCFA-3FEF3F4ED9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2D75D-E5F8-408A-8764-973140BD05B8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6BAAFA-27F8-8EA2-E4FE-5033D0B965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1F9404-F690-B825-0FE5-6908C8A394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60084-4842-4A3D-94A1-E3E85F138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10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433E8-0CB5-1EB6-5A7E-254F165F38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56446"/>
            <a:ext cx="9144000" cy="847445"/>
          </a:xfrm>
        </p:spPr>
        <p:txBody>
          <a:bodyPr>
            <a:normAutofit/>
          </a:bodyPr>
          <a:lstStyle/>
          <a:p>
            <a:r>
              <a:rPr lang="en-US" sz="32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upplementary Information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DAC5D3-B13F-ED75-234B-968B47113F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2601119"/>
            <a:ext cx="9144000" cy="1655762"/>
          </a:xfrm>
        </p:spPr>
        <p:txBody>
          <a:bodyPr>
            <a:noAutofit/>
          </a:bodyPr>
          <a:lstStyle/>
          <a:p>
            <a:r>
              <a:rPr lang="en-US" sz="3200" dirty="0"/>
              <a:t>Dynamic Deformation in Nuclear Graphite and Fundamental Mechanisms</a:t>
            </a:r>
          </a:p>
          <a:p>
            <a:endParaRPr lang="en-US" sz="3200" dirty="0"/>
          </a:p>
          <a:p>
            <a:endParaRPr lang="en-US" sz="3200" dirty="0"/>
          </a:p>
          <a:p>
            <a:r>
              <a:rPr lang="en-US" dirty="0"/>
              <a:t>Melonie Thomas, Hajin Oh, Ryan Schoell, Stephen House, Khalid Hattar, William Windes, Aman Haque</a:t>
            </a:r>
          </a:p>
        </p:txBody>
      </p:sp>
    </p:spTree>
    <p:extLst>
      <p:ext uri="{BB962C8B-B14F-4D97-AF65-F5344CB8AC3E}">
        <p14:creationId xmlns:p14="http://schemas.microsoft.com/office/powerpoint/2010/main" val="2701225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C175522-B46D-39AD-B103-01E937B5CF17}"/>
              </a:ext>
            </a:extLst>
          </p:cNvPr>
          <p:cNvSpPr txBox="1"/>
          <p:nvPr/>
        </p:nvSpPr>
        <p:spPr>
          <a:xfrm>
            <a:off x="3056415" y="45814"/>
            <a:ext cx="71005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In-situ TEM Micro-pillar Dynamic Testing</a:t>
            </a:r>
          </a:p>
        </p:txBody>
      </p:sp>
      <p:pic>
        <p:nvPicPr>
          <p:cNvPr id="3" name="MPT_Au_NG_pillar1 LC_150uN LC_sbs10x">
            <a:hlinkClick r:id="" action="ppaction://media"/>
            <a:extLst>
              <a:ext uri="{FF2B5EF4-FFF2-40B4-BE49-F238E27FC236}">
                <a16:creationId xmlns:a16="http://schemas.microsoft.com/office/drawing/2014/main" id="{D443CCA3-C7A2-00B5-AD4D-046E125D648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734785" y="630589"/>
            <a:ext cx="10722430" cy="6005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39320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054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35</Words>
  <Application>Microsoft Office PowerPoint</Application>
  <PresentationFormat>Widescreen</PresentationFormat>
  <Paragraphs>6</Paragraphs>
  <Slides>2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ementary Inform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cropillar compression creep tests on 11/14</dc:title>
  <dc:creator>Melonie Thomas</dc:creator>
  <cp:lastModifiedBy>Haque, Md Amanul</cp:lastModifiedBy>
  <cp:revision>11</cp:revision>
  <dcterms:created xsi:type="dcterms:W3CDTF">2023-11-21T17:12:00Z</dcterms:created>
  <dcterms:modified xsi:type="dcterms:W3CDTF">2024-08-14T20:31:26Z</dcterms:modified>
</cp:coreProperties>
</file>